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6119813" cy="75596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28" autoAdjust="0"/>
    <p:restoredTop sz="94660"/>
  </p:normalViewPr>
  <p:slideViewPr>
    <p:cSldViewPr snapToGrid="0">
      <p:cViewPr varScale="1">
        <p:scale>
          <a:sx n="136" d="100"/>
          <a:sy n="136" d="100"/>
        </p:scale>
        <p:origin x="282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F8E6B0-4FB7-431F-967A-935046A18B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64977" y="1237197"/>
            <a:ext cx="4589860" cy="2631887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744A909-1339-4219-8786-F2D464B9E9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64977" y="3970580"/>
            <a:ext cx="4589860" cy="1825171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E4294B-7E1B-4156-8CF4-A5FFAFEE4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D827D9-C0F4-43D2-A3E7-98EB8DF83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AD6573-3A58-4A9B-A1FC-0AB599ACB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2227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51176C-A6C2-4C4D-87A6-A698CB06B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5DD9E7-94E3-4D57-8EC8-83D8518DEF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2683EA-E27C-4C9B-B62C-10A0EFF10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224ECE-732B-44FD-BC8C-DB06581F0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E7422D-BD22-4D17-8EAA-688459865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1915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E19B64A-16BF-4BC8-B407-69AB1CA64E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379491" y="402483"/>
            <a:ext cx="1319585" cy="64064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366BF1-86C0-49F4-89A6-5F2FBE600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20737" y="402483"/>
            <a:ext cx="3882256" cy="64064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2E9158-E307-4FBA-B0E9-45043B677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32CDC6-8454-46CE-BD57-DFF245AD3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6E99EF-FB74-468F-8776-F85C49C1A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901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2E3397-FAD6-4687-8A02-5A84C31D6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DAE97B-1170-4BF6-829D-086E9CF7F8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B94E62-F801-4D4A-AE9D-648FDC5E0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67E12A-A879-49C9-8C1F-E60E67392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3B10CF-68DF-42C2-A71A-501D7A785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7585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82C630-F192-4095-83C2-A68BEE1BBE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7550" y="1884670"/>
            <a:ext cx="5278339" cy="3144614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BE95A6-1847-4BDA-A2FF-2C80DE892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17550" y="5059034"/>
            <a:ext cx="5278339" cy="165367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3FDC67-25ED-40EA-975F-70A9D07BF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8FC705-6C98-4A67-87BD-E181F292B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FD1155-4938-4D1C-A642-21A58C90D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945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3112D7-A02F-4111-A4E8-1D9FD1738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8779E6-41D5-4C4E-AA78-1825339747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20737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E088A7-C1F9-4433-B4CA-6388188E0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098155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784B8A-49C4-4AD0-B778-999DB46E8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0AF43B-EAB6-4EC0-A63D-95FE37C4C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5EB91E9-28EC-4491-B784-BDC5FCE7C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5186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A1C149-264E-4687-9A0F-2E6C0E690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402483"/>
            <a:ext cx="5278339" cy="1461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33F7D2-CEE4-4674-8BB5-26AB9F174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1534" y="1853171"/>
            <a:ext cx="2588968" cy="908210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074AF2-7544-4024-8E05-52F695B325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1534" y="2761381"/>
            <a:ext cx="2588968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839E13A-E2BE-4414-923D-2CEBE1306A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098155" y="1853171"/>
            <a:ext cx="2601718" cy="908210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9C40EEF-F43F-4627-83B3-C93C24BA28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098155" y="2761381"/>
            <a:ext cx="2601718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94BDAFB-5FF1-403A-AD6D-00A6591D4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7883C85-2795-4DDB-961D-313CE2C66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FCA1F1B-2559-4EAE-AF87-F81562F31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046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D5CF40-C47D-48D7-916E-B8A24731D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9FCF2A9-F6B2-4938-8620-854D4AFF26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86A336-5F7E-4009-9F00-6834D2C21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15D7AD5-6752-41AF-978A-E9EB21AC1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448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829F5F6-7EB2-4EDA-B75F-1976D2EBE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DE780B3-F1D8-4AC4-B255-A1B605E65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EB9D2CE-91C0-47C1-85FF-9E83D56CA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941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0B960E-7B93-4FD1-8D18-BF0E2CA331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99C364-E90F-4724-818B-0C9AFAB588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01718" y="1088454"/>
            <a:ext cx="3098155" cy="5372269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7BF18D-F5E5-48ED-BB2E-A9A44A5C75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FCDAD0-CC2D-4E81-8D22-A1C06107E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7651DD-E3FC-4E61-B448-AD30B8913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7C6D8C-D8AA-49A3-9C7A-14B0AB488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93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232B9B-4F6A-468D-A762-3386D177B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20FC9A5-4C03-4EC1-905D-4A4D828F6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601718" y="1088454"/>
            <a:ext cx="3098155" cy="5372269"/>
          </a:xfrm>
        </p:spPr>
        <p:txBody>
          <a:bodyPr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EA0F77-D4B7-4BC5-93F2-CF08C285B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43546E-68EE-4277-8557-E48E6416F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E544AA-E31A-4BDF-8288-40975548D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A8A484-A2D2-4A63-84B7-496C51F65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611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904C208-6889-4CF5-981E-1451463DE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737" y="402483"/>
            <a:ext cx="527833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99C786-4E9F-446A-99A2-36156E969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0737" y="2012414"/>
            <a:ext cx="527833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E25615-EFD5-4B3B-A464-8E9756F23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20737" y="7006699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D01C9-9DB5-4F94-A4D9-FF6D522116B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2411AD-4D64-4C3C-B572-C02CA55F16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027188" y="7006699"/>
            <a:ext cx="206543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4773A1-DB40-4960-8656-069B49D0C5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322118" y="7006699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5025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59029" rtl="0" eaLnBrk="1" latinLnBrk="0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0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5F9BA29-C13C-452B-BE0F-2DCC9511272D}"/>
              </a:ext>
            </a:extLst>
          </p:cNvPr>
          <p:cNvSpPr txBox="1"/>
          <p:nvPr/>
        </p:nvSpPr>
        <p:spPr>
          <a:xfrm>
            <a:off x="764690" y="175847"/>
            <a:ext cx="223882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Tables </a:t>
            </a:r>
            <a:endParaRPr lang="zh-CN" altLang="zh-CN" sz="14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86A40D19-2C19-45FC-9C1D-85D5E73223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66382"/>
              </p:ext>
            </p:extLst>
          </p:nvPr>
        </p:nvGraphicFramePr>
        <p:xfrm>
          <a:off x="1029455" y="825508"/>
          <a:ext cx="4060902" cy="3048000"/>
        </p:xfrm>
        <a:graphic>
          <a:graphicData uri="http://schemas.openxmlformats.org/drawingml/2006/table">
            <a:tbl>
              <a:tblPr firstRow="1" firstCol="1" bandRow="1"/>
              <a:tblGrid>
                <a:gridCol w="941659">
                  <a:extLst>
                    <a:ext uri="{9D8B030D-6E8A-4147-A177-3AD203B41FA5}">
                      <a16:colId xmlns:a16="http://schemas.microsoft.com/office/drawing/2014/main" val="2559666328"/>
                    </a:ext>
                  </a:extLst>
                </a:gridCol>
                <a:gridCol w="976535">
                  <a:extLst>
                    <a:ext uri="{9D8B030D-6E8A-4147-A177-3AD203B41FA5}">
                      <a16:colId xmlns:a16="http://schemas.microsoft.com/office/drawing/2014/main" val="1650345619"/>
                    </a:ext>
                  </a:extLst>
                </a:gridCol>
                <a:gridCol w="2142708">
                  <a:extLst>
                    <a:ext uri="{9D8B030D-6E8A-4147-A177-3AD203B41FA5}">
                      <a16:colId xmlns:a16="http://schemas.microsoft.com/office/drawing/2014/main" val="2225072634"/>
                    </a:ext>
                  </a:extLst>
                </a:gridCol>
              </a:tblGrid>
              <a:tr h="121856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dentification</a:t>
                      </a:r>
                      <a:endParaRPr lang="zh-CN" sz="8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IMER SEQUENCE (5</a:t>
                      </a:r>
                      <a:r>
                        <a:rPr lang="zh-CN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‘</a:t>
                      </a: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zh-CN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‘</a:t>
                      </a: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1652148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eyL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TCTTGCAGATGACGGT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397182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TAGCTGTTGAGGTGGGA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1038568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YP19A1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GTCAGAGTAGAACCCCTGA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5665908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CAATTTATCCATGACCAC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7749193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D44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CAACACCTCCCAGTAT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6824582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TGGACATAGCGGGT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178644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OX2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GCGAACCATCTCTGTGGT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0199002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ACGGTGTCAACCTGCAT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848076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LF4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GAGAAGACACTGCGTCA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1624283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GGATCGGATAGGTGA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0701336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CT4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GAGGAAGCTGACAACA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6932452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CTCCAGGTTGCCTCTC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690615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CL2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 ACT GAG TAC CTG AAC C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883469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 ACA TCA CTG ACA ATG C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7688810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AX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GAGAGGTCTTTTTCCGA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912505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GCCCATGATGGTTCTGAT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2236285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PRT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CACTGGCAAAACAATGC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5354963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TCCTTTTCACCAGCAAGCT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508567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C3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GAGAGCAGCATCCAACC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9987996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TTGGTGTGGAGACGCTGA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399566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eclin1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CTCGCAGATTCATCCCCC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9681738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TTGAGCTGAGTGTCCA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923988"/>
                  </a:ext>
                </a:extLst>
              </a:tr>
              <a:tr h="121856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i="1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mTOR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nse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CTGTCCCTGGTCCTTATG</a:t>
                      </a:r>
                      <a:endParaRPr lang="zh-CN" sz="8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4902986"/>
                  </a:ext>
                </a:extLst>
              </a:tr>
              <a:tr h="12185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ntisense</a:t>
                      </a:r>
                      <a:endParaRPr lang="zh-CN" sz="8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TCAGAGAGTGGCCTTCAA</a:t>
                      </a:r>
                      <a:endParaRPr lang="zh-CN" sz="8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224" marR="522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603136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1F32174B-0DAC-4322-9F11-A16252C64B19}"/>
              </a:ext>
            </a:extLst>
          </p:cNvPr>
          <p:cNvSpPr txBox="1"/>
          <p:nvPr/>
        </p:nvSpPr>
        <p:spPr>
          <a:xfrm>
            <a:off x="973184" y="528422"/>
            <a:ext cx="34370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1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rimer 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sequences in </a:t>
            </a:r>
            <a:r>
              <a:rPr lang="en-US" altLang="zh-CN" sz="1200" dirty="0" err="1">
                <a:latin typeface="Times New Roman" panose="02020603050405020304" pitchFamily="18" charset="0"/>
                <a:ea typeface="等线" panose="02010600030101010101" pitchFamily="2" charset="-122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-PCR assay</a:t>
            </a:r>
            <a:endParaRPr lang="zh-CN" altLang="zh-CN" sz="12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3031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5F9A513A-2BB3-4D68-B0E2-89ABE16566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105696"/>
              </p:ext>
            </p:extLst>
          </p:nvPr>
        </p:nvGraphicFramePr>
        <p:xfrm>
          <a:off x="913153" y="743143"/>
          <a:ext cx="4030335" cy="4343506"/>
        </p:xfrm>
        <a:graphic>
          <a:graphicData uri="http://schemas.openxmlformats.org/drawingml/2006/table">
            <a:tbl>
              <a:tblPr firstRow="1" firstCol="1" bandRow="1"/>
              <a:tblGrid>
                <a:gridCol w="1387693">
                  <a:extLst>
                    <a:ext uri="{9D8B030D-6E8A-4147-A177-3AD203B41FA5}">
                      <a16:colId xmlns:a16="http://schemas.microsoft.com/office/drawing/2014/main" val="2679819696"/>
                    </a:ext>
                  </a:extLst>
                </a:gridCol>
                <a:gridCol w="77736">
                  <a:extLst>
                    <a:ext uri="{9D8B030D-6E8A-4147-A177-3AD203B41FA5}">
                      <a16:colId xmlns:a16="http://schemas.microsoft.com/office/drawing/2014/main" val="3001836613"/>
                    </a:ext>
                  </a:extLst>
                </a:gridCol>
                <a:gridCol w="2564906">
                  <a:extLst>
                    <a:ext uri="{9D8B030D-6E8A-4147-A177-3AD203B41FA5}">
                      <a16:colId xmlns:a16="http://schemas.microsoft.com/office/drawing/2014/main" val="1461780758"/>
                    </a:ext>
                  </a:extLst>
                </a:gridCol>
              </a:tblGrid>
              <a:tr h="155070"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ame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QUENCE (5</a:t>
                      </a:r>
                      <a:r>
                        <a:rPr lang="zh-CN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‘</a:t>
                      </a: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zh-CN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‘</a:t>
                      </a: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245613"/>
                  </a:ext>
                </a:extLst>
              </a:tr>
              <a:tr h="155070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HeyL-1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GCAUUGGUUUUCGGG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4272227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CCCGAAAACCAAUGCUCCGG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7475910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HeyL-2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ACGCAGAGGGAUCAU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863117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AUGAUCCCUCUGCGUUU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0241158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HeyL-3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AUGACGGUGGAUCACUUTT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50110230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UGAUCCACCGUCAUCUGC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2147007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CYP19A1-1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UAUGUUCCACAUAAUGA 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4122251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UCAUUAUGUGGAACAUA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4322591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CYP19A1-2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UGGAAUUAUGAGGGCAC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3232275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GUGCCCUCAUA AUUCCA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3877091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CYP19A1-3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GUAUGCAUGAGAAAGGCAUCAUA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9428095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AUGAUGCCUUUCUCAUGCAUACCG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5038320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ESR1-1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CAUCGCAUUCCUUGCAA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1402207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UUGCAAGGAAUGCGAUG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8018599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ESR1-2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GGAGGGAGAAUGUUGAA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736787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UUCAACAUUCUCCCUCCU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5350014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ESR1-3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UACUGUUUGCUCCUAA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0149644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UUAGGAGCAAACAGUAGCTT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7441052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cDNA3.1-HeyL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GGAATTCATGAAGCGACCCAAGGAGC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2415228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GCTCGAGCCTTCCTTATTCCTTGGGGC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0087162"/>
                  </a:ext>
                </a:extLst>
              </a:tr>
              <a:tr h="186084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_HeyL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CGGGCTCCGACGGGGAGTCCGA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CTCGGACTCCCCGTCGGAGCCC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4739300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_HeyL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CGAGCCGTGGGAAGGCCCTAGG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3990429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CCCTAGGGCCTTCCCACGGCTC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6902361"/>
                  </a:ext>
                </a:extLst>
              </a:tr>
              <a:tr h="164762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acZ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CGCCCGAATCTCTATCGTGCGG</a:t>
                      </a:r>
                      <a:endParaRPr lang="zh-CN" sz="8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3745194"/>
                  </a:ext>
                </a:extLst>
              </a:tr>
              <a:tr h="1647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CCCGCACGATAGAGATTCGGGC</a:t>
                      </a:r>
                      <a:endParaRPr lang="zh-CN" sz="8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336" marR="523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1821123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BFFDFF64-AA32-4C54-94B8-B003327BBFFA}"/>
              </a:ext>
            </a:extLst>
          </p:cNvPr>
          <p:cNvSpPr txBox="1"/>
          <p:nvPr/>
        </p:nvSpPr>
        <p:spPr>
          <a:xfrm>
            <a:off x="913153" y="281478"/>
            <a:ext cx="393316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2 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siRNA sequences and primer sequences used in plasmid construction.</a:t>
            </a:r>
            <a:endParaRPr lang="zh-CN" altLang="zh-CN" sz="12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1791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8</Words>
  <Application>Microsoft Office PowerPoint</Application>
  <PresentationFormat>自定义</PresentationFormat>
  <Paragraphs>10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启妹</dc:creator>
  <cp:lastModifiedBy>林 启妹</cp:lastModifiedBy>
  <cp:revision>3</cp:revision>
  <dcterms:created xsi:type="dcterms:W3CDTF">2021-09-30T14:19:19Z</dcterms:created>
  <dcterms:modified xsi:type="dcterms:W3CDTF">2021-10-01T08:53:11Z</dcterms:modified>
</cp:coreProperties>
</file>